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A058B4-428A-42BF-9816-BE5532FA2E8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9EECB6-6EBC-4527-A901-2EF1DAC38FD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343C8B-6843-4E6C-85CE-C60DED3C2F8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0EA510-1C7C-4F92-B773-2B2A1044ACC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F2889A-3082-4970-9938-754001FDD9E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99D9DD-2625-403D-B8AE-53047B33621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ED8958-8479-4076-8F10-8565561067C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078DCF-2571-46D4-9CB4-815ABC43E1B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CD390C-AB03-4207-902C-3C59225AE29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A0D7F7-6AB4-4370-80A4-90977F655A3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FF0F30-873D-4CB3-8E02-6CA37EDAED4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403C40-5A2C-4C9A-A60B-D334AAC2F6A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0781EDA-8BE0-443A-A187-8B6EFB18F47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519200" y="1870200"/>
            <a:ext cx="0" cy="2000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1481040" y="3870360"/>
            <a:ext cx="381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1481040" y="3670200"/>
            <a:ext cx="381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1481040" y="3470400"/>
            <a:ext cx="381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1481040" y="3270240"/>
            <a:ext cx="381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1481040" y="3070080"/>
            <a:ext cx="381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1481040" y="2870280"/>
            <a:ext cx="381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1481040" y="2670120"/>
            <a:ext cx="381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1481040" y="2470320"/>
            <a:ext cx="381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1481040" y="2270160"/>
            <a:ext cx="381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1481040" y="2070000"/>
            <a:ext cx="381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1481040" y="1870200"/>
            <a:ext cx="381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1519200" y="3870360"/>
            <a:ext cx="41385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 flipV="1">
            <a:off x="1519200" y="3870360"/>
            <a:ext cx="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 flipV="1">
            <a:off x="2205000" y="3870360"/>
            <a:ext cx="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 flipV="1">
            <a:off x="2900520" y="3870360"/>
            <a:ext cx="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 flipV="1">
            <a:off x="3586320" y="3870360"/>
            <a:ext cx="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 flipV="1">
            <a:off x="4281480" y="3870360"/>
            <a:ext cx="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 flipV="1">
            <a:off x="4967280" y="3870360"/>
            <a:ext cx="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 flipV="1">
            <a:off x="5662440" y="3870360"/>
            <a:ext cx="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1356840" y="379404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1251720" y="359424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Arial"/>
              </a:rPr>
              <a:t>0.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1251720" y="339408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Arial"/>
              </a:rPr>
              <a:t>1.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1251720" y="319392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Arial"/>
              </a:rPr>
              <a:t>1.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1251720" y="299412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Arial"/>
              </a:rPr>
              <a:t>2.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1251720" y="279396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Arial"/>
              </a:rPr>
              <a:t>2.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1251720" y="259380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Arial"/>
              </a:rPr>
              <a:t>3.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1251720" y="239400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Arial"/>
              </a:rPr>
              <a:t>3.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1251720" y="219384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Arial"/>
              </a:rPr>
              <a:t>4.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1251720" y="199404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Arial"/>
              </a:rPr>
              <a:t>4.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1251720" y="179388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Arial"/>
              </a:rPr>
              <a:t>5.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2" name=""/>
          <p:cNvGrpSpPr/>
          <p:nvPr/>
        </p:nvGrpSpPr>
        <p:grpSpPr>
          <a:xfrm>
            <a:off x="3038400" y="2610000"/>
            <a:ext cx="477360" cy="1517400"/>
            <a:chOff x="3038400" y="2610000"/>
            <a:chExt cx="477360" cy="1517400"/>
          </a:xfrm>
        </p:grpSpPr>
        <p:sp>
          <p:nvSpPr>
            <p:cNvPr id="73" name=""/>
            <p:cNvSpPr/>
            <p:nvPr/>
          </p:nvSpPr>
          <p:spPr>
            <a:xfrm>
              <a:off x="3072960" y="2610000"/>
              <a:ext cx="398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    </a:t>
              </a: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3038400" y="3470040"/>
              <a:ext cx="199800" cy="3996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3238200" y="3165120"/>
              <a:ext cx="200160" cy="7045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 flipV="1">
              <a:off x="3133440" y="3450960"/>
              <a:ext cx="0" cy="18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3105000" y="3450960"/>
              <a:ext cx="66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 flipV="1">
              <a:off x="3333600" y="2841480"/>
              <a:ext cx="0" cy="323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3305160" y="2841480"/>
              <a:ext cx="66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3057840" y="3974760"/>
              <a:ext cx="457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NLRP-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1" name=""/>
          <p:cNvGrpSpPr/>
          <p:nvPr/>
        </p:nvGrpSpPr>
        <p:grpSpPr>
          <a:xfrm>
            <a:off x="1682640" y="3165120"/>
            <a:ext cx="390600" cy="962280"/>
            <a:chOff x="1682640" y="3165120"/>
            <a:chExt cx="390600" cy="962280"/>
          </a:xfrm>
        </p:grpSpPr>
        <p:sp>
          <p:nvSpPr>
            <p:cNvPr id="82" name=""/>
            <p:cNvSpPr/>
            <p:nvPr/>
          </p:nvSpPr>
          <p:spPr>
            <a:xfrm>
              <a:off x="1682640" y="3470040"/>
              <a:ext cx="200160" cy="3996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1882800" y="3374640"/>
              <a:ext cx="190440" cy="49500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 flipV="1">
              <a:off x="1778040" y="3450960"/>
              <a:ext cx="0" cy="18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1749240" y="3450960"/>
              <a:ext cx="66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 flipV="1">
              <a:off x="1977840" y="3165120"/>
              <a:ext cx="0" cy="209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1949400" y="3165480"/>
              <a:ext cx="66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1748880" y="3974760"/>
              <a:ext cx="304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IL-1</a:t>
              </a:r>
              <a:r>
                <a:rPr b="1" lang="el-G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β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9" name=""/>
          <p:cNvGrpSpPr/>
          <p:nvPr/>
        </p:nvGrpSpPr>
        <p:grpSpPr>
          <a:xfrm>
            <a:off x="3705120" y="2903400"/>
            <a:ext cx="414360" cy="1224000"/>
            <a:chOff x="3705120" y="2903400"/>
            <a:chExt cx="414360" cy="1224000"/>
          </a:xfrm>
        </p:grpSpPr>
        <p:sp>
          <p:nvSpPr>
            <p:cNvPr id="90" name=""/>
            <p:cNvSpPr/>
            <p:nvPr/>
          </p:nvSpPr>
          <p:spPr>
            <a:xfrm>
              <a:off x="3868560" y="290340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3705120" y="3470040"/>
              <a:ext cx="200160" cy="3999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3905280" y="3317760"/>
              <a:ext cx="199800" cy="55224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 flipV="1">
              <a:off x="3800520" y="3459960"/>
              <a:ext cx="0" cy="9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3771720" y="3460320"/>
              <a:ext cx="66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 flipV="1">
              <a:off x="4000320" y="3183840"/>
              <a:ext cx="0" cy="133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3971880" y="3184200"/>
              <a:ext cx="66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3791160" y="3974760"/>
              <a:ext cx="267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AS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8" name=""/>
          <p:cNvGrpSpPr/>
          <p:nvPr/>
        </p:nvGrpSpPr>
        <p:grpSpPr>
          <a:xfrm>
            <a:off x="2338560" y="2052720"/>
            <a:ext cx="414360" cy="2074680"/>
            <a:chOff x="2338560" y="2052720"/>
            <a:chExt cx="414360" cy="2074680"/>
          </a:xfrm>
        </p:grpSpPr>
        <p:sp>
          <p:nvSpPr>
            <p:cNvPr id="99" name=""/>
            <p:cNvSpPr/>
            <p:nvPr/>
          </p:nvSpPr>
          <p:spPr>
            <a:xfrm>
              <a:off x="2431800" y="2052720"/>
              <a:ext cx="321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2338560" y="3470040"/>
              <a:ext cx="199800" cy="3996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2538360" y="2784240"/>
              <a:ext cx="190440" cy="108540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 flipV="1">
              <a:off x="2433600" y="3441600"/>
              <a:ext cx="0" cy="28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2405160" y="3441600"/>
              <a:ext cx="66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 flipV="1">
              <a:off x="2633760" y="2317320"/>
              <a:ext cx="0" cy="466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2605320" y="2317320"/>
              <a:ext cx="66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2376720" y="3974760"/>
              <a:ext cx="367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TNF-</a:t>
              </a:r>
              <a:r>
                <a:rPr b="1" lang="el-G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α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7" name=""/>
          <p:cNvGrpSpPr/>
          <p:nvPr/>
        </p:nvGrpSpPr>
        <p:grpSpPr>
          <a:xfrm>
            <a:off x="4379760" y="1908000"/>
            <a:ext cx="424800" cy="2219400"/>
            <a:chOff x="4379760" y="1908000"/>
            <a:chExt cx="424800" cy="2219400"/>
          </a:xfrm>
        </p:grpSpPr>
        <p:sp>
          <p:nvSpPr>
            <p:cNvPr id="108" name=""/>
            <p:cNvSpPr/>
            <p:nvPr/>
          </p:nvSpPr>
          <p:spPr>
            <a:xfrm>
              <a:off x="4546080" y="190800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4379760" y="3470040"/>
              <a:ext cx="199800" cy="3999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4579560" y="2898360"/>
              <a:ext cx="200160" cy="97164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 flipV="1">
              <a:off x="4474800" y="3459960"/>
              <a:ext cx="0" cy="9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4446360" y="3460320"/>
              <a:ext cx="66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 flipV="1">
              <a:off x="4674960" y="2136600"/>
              <a:ext cx="0" cy="761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4646520" y="2136600"/>
              <a:ext cx="66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4389480" y="3974760"/>
              <a:ext cx="415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TIMP-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6" name=""/>
          <p:cNvGrpSpPr/>
          <p:nvPr/>
        </p:nvGrpSpPr>
        <p:grpSpPr>
          <a:xfrm>
            <a:off x="5075280" y="2700360"/>
            <a:ext cx="417600" cy="1427040"/>
            <a:chOff x="5075280" y="2700360"/>
            <a:chExt cx="417600" cy="1427040"/>
          </a:xfrm>
        </p:grpSpPr>
        <p:sp>
          <p:nvSpPr>
            <p:cNvPr id="117" name=""/>
            <p:cNvSpPr/>
            <p:nvPr/>
          </p:nvSpPr>
          <p:spPr>
            <a:xfrm>
              <a:off x="5207040" y="2700360"/>
              <a:ext cx="285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5075280" y="3470040"/>
              <a:ext cx="200160" cy="3996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5275440" y="3241440"/>
              <a:ext cx="190440" cy="62820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 flipV="1">
              <a:off x="5170680" y="3450960"/>
              <a:ext cx="0" cy="18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5141880" y="3450960"/>
              <a:ext cx="66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 flipV="1">
              <a:off x="5370480" y="2945880"/>
              <a:ext cx="0" cy="294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5342040" y="2946240"/>
              <a:ext cx="66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5076360" y="3974760"/>
              <a:ext cx="407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MMP-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5" name=""/>
          <p:cNvSpPr/>
          <p:nvPr/>
        </p:nvSpPr>
        <p:spPr>
          <a:xfrm rot="16200000">
            <a:off x="288000" y="2733840"/>
            <a:ext cx="15674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Arial"/>
              </a:rPr>
              <a:t>relative mRNA express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2509920" y="4251240"/>
            <a:ext cx="2552760" cy="228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2814480" y="4327560"/>
            <a:ext cx="76320" cy="763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2938320" y="4289400"/>
            <a:ext cx="5446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</a:rPr>
              <a:t>wild type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4119480" y="4327560"/>
            <a:ext cx="76320" cy="763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4246560" y="4289400"/>
            <a:ext cx="4442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de-DE" sz="1100" spc="-1" strike="noStrike">
                <a:solidFill>
                  <a:srgbClr val="000000"/>
                </a:solidFill>
                <a:latin typeface="Arial"/>
              </a:rPr>
              <a:t>Atp7b</a:t>
            </a:r>
            <a:r>
              <a:rPr b="0" lang="de-DE" sz="1100" spc="-1" strike="noStrike" baseline="30000">
                <a:solidFill>
                  <a:srgbClr val="000000"/>
                </a:solidFill>
                <a:latin typeface="Arial"/>
              </a:rPr>
              <a:t>-/-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770400" y="151920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2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770400" y="475776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2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4868640" y="8091360"/>
            <a:ext cx="183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</a:rPr>
              <a:t>Suppl. Figure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4875480" y="5573880"/>
            <a:ext cx="451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141515"/>
                </a:solidFill>
                <a:latin typeface="Arial"/>
              </a:rPr>
              <a:t>TNF-R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4874760" y="6827760"/>
            <a:ext cx="416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l-GR" sz="1000" spc="-1" strike="noStrike">
                <a:solidFill>
                  <a:srgbClr val="141515"/>
                </a:solidFill>
                <a:latin typeface="Arial"/>
                <a:ea typeface="Arial"/>
              </a:rPr>
              <a:t>β</a:t>
            </a:r>
            <a:r>
              <a:rPr b="1" lang="de-DE" sz="1000" spc="-1" strike="noStrike">
                <a:solidFill>
                  <a:srgbClr val="141515"/>
                </a:solidFill>
                <a:latin typeface="Arial"/>
              </a:rPr>
              <a:t>-act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4875480" y="6545160"/>
            <a:ext cx="415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141515"/>
                </a:solidFill>
                <a:latin typeface="Arial"/>
              </a:rPr>
              <a:t>TIMP-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4875840" y="5888160"/>
            <a:ext cx="401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l-GR" sz="1000" spc="-1" strike="noStrike">
                <a:solidFill>
                  <a:srgbClr val="141515"/>
                </a:solidFill>
                <a:latin typeface="Arial"/>
                <a:ea typeface="Arial"/>
              </a:rPr>
              <a:t>α</a:t>
            </a:r>
            <a:r>
              <a:rPr b="1" lang="de-DE" sz="1000" spc="-1" strike="noStrike">
                <a:solidFill>
                  <a:srgbClr val="141515"/>
                </a:solidFill>
                <a:latin typeface="Arial"/>
                <a:ea typeface="Arial"/>
              </a:rPr>
              <a:t>-</a:t>
            </a:r>
            <a:r>
              <a:rPr b="1" lang="de-DE" sz="1000" spc="-1" strike="noStrike">
                <a:solidFill>
                  <a:srgbClr val="141515"/>
                </a:solidFill>
                <a:latin typeface="Arial"/>
              </a:rPr>
              <a:t>SM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4875120" y="6243480"/>
            <a:ext cx="3315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141515"/>
                </a:solidFill>
                <a:latin typeface="Arial"/>
              </a:rPr>
              <a:t>LCN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2133720" y="5232240"/>
            <a:ext cx="1224000" cy="360"/>
          </a:xfrm>
          <a:custGeom>
            <a:avLst/>
            <a:gdLst/>
            <a:ahLst/>
            <a:rect l="l" t="t" r="r" b="b"/>
            <a:pathLst>
              <a:path w="4500" h="0">
                <a:moveTo>
                  <a:pt x="0" y="0"/>
                </a:moveTo>
                <a:cubicBezTo>
                  <a:pt x="1487" y="0"/>
                  <a:pt x="3013" y="0"/>
                  <a:pt x="4500" y="0"/>
                </a:cubicBezTo>
              </a:path>
            </a:pathLst>
          </a:custGeom>
          <a:noFill/>
          <a:ln w="19080">
            <a:solidFill>
              <a:srgbClr val="14151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>
            <a:off x="3411360" y="5232240"/>
            <a:ext cx="1224000" cy="360"/>
          </a:xfrm>
          <a:custGeom>
            <a:avLst/>
            <a:gdLst/>
            <a:ahLst/>
            <a:rect l="l" t="t" r="r" b="b"/>
            <a:pathLst>
              <a:path w="4500" h="0">
                <a:moveTo>
                  <a:pt x="0" y="0"/>
                </a:moveTo>
                <a:cubicBezTo>
                  <a:pt x="1487" y="0"/>
                  <a:pt x="3013" y="0"/>
                  <a:pt x="4500" y="0"/>
                </a:cubicBezTo>
              </a:path>
            </a:pathLst>
          </a:custGeom>
          <a:noFill/>
          <a:ln w="19080">
            <a:solidFill>
              <a:srgbClr val="14151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1" name="" descr=""/>
          <p:cNvPicPr/>
          <p:nvPr/>
        </p:nvPicPr>
        <p:blipFill>
          <a:blip r:embed="rId1"/>
          <a:stretch/>
        </p:blipFill>
        <p:spPr>
          <a:xfrm>
            <a:off x="2079720" y="5526000"/>
            <a:ext cx="2581200" cy="2286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42" name="" descr=""/>
          <p:cNvPicPr/>
          <p:nvPr/>
        </p:nvPicPr>
        <p:blipFill>
          <a:blip r:embed="rId2"/>
          <a:stretch/>
        </p:blipFill>
        <p:spPr>
          <a:xfrm>
            <a:off x="2079720" y="5859360"/>
            <a:ext cx="2579760" cy="2444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143" name=""/>
          <p:cNvSpPr/>
          <p:nvPr/>
        </p:nvSpPr>
        <p:spPr>
          <a:xfrm>
            <a:off x="1874880" y="5992920"/>
            <a:ext cx="131760" cy="360"/>
          </a:xfrm>
          <a:custGeom>
            <a:avLst/>
            <a:gdLst/>
            <a:ahLst/>
            <a:rect l="l" t="t" r="r" b="b"/>
            <a:pathLst>
              <a:path w="485" h="0">
                <a:moveTo>
                  <a:pt x="0" y="0"/>
                </a:moveTo>
                <a:cubicBezTo>
                  <a:pt x="48" y="0"/>
                  <a:pt x="121" y="0"/>
                  <a:pt x="169" y="0"/>
                </a:cubicBezTo>
                <a:cubicBezTo>
                  <a:pt x="169" y="0"/>
                  <a:pt x="242" y="0"/>
                  <a:pt x="242" y="0"/>
                </a:cubicBezTo>
                <a:cubicBezTo>
                  <a:pt x="242" y="0"/>
                  <a:pt x="291" y="0"/>
                  <a:pt x="291" y="0"/>
                </a:cubicBezTo>
                <a:cubicBezTo>
                  <a:pt x="291" y="0"/>
                  <a:pt x="339" y="0"/>
                  <a:pt x="339" y="0"/>
                </a:cubicBezTo>
                <a:lnTo>
                  <a:pt x="363" y="0"/>
                </a:lnTo>
                <a:cubicBezTo>
                  <a:pt x="363" y="0"/>
                  <a:pt x="388" y="0"/>
                  <a:pt x="388" y="0"/>
                </a:cubicBezTo>
                <a:cubicBezTo>
                  <a:pt x="436" y="0"/>
                  <a:pt x="485" y="0"/>
                  <a:pt x="436" y="0"/>
                </a:cubicBezTo>
              </a:path>
            </a:pathLst>
          </a:custGeom>
          <a:noFill/>
          <a:ln w="19080">
            <a:solidFill>
              <a:srgbClr val="14151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1684080" y="592596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141515"/>
                </a:solidFill>
                <a:latin typeface="Arial"/>
              </a:rPr>
              <a:t>4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5" name="" descr=""/>
          <p:cNvPicPr/>
          <p:nvPr/>
        </p:nvPicPr>
        <p:blipFill>
          <a:blip r:embed="rId3"/>
          <a:srcRect l="0" t="0" r="1318" b="0"/>
          <a:stretch/>
        </p:blipFill>
        <p:spPr>
          <a:xfrm>
            <a:off x="2079720" y="6211800"/>
            <a:ext cx="2579760" cy="2239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146" name=""/>
          <p:cNvSpPr/>
          <p:nvPr/>
        </p:nvSpPr>
        <p:spPr>
          <a:xfrm>
            <a:off x="1874880" y="6297480"/>
            <a:ext cx="131760" cy="360"/>
          </a:xfrm>
          <a:custGeom>
            <a:avLst/>
            <a:gdLst/>
            <a:ahLst/>
            <a:rect l="l" t="t" r="r" b="b"/>
            <a:pathLst>
              <a:path w="485" h="0">
                <a:moveTo>
                  <a:pt x="0" y="0"/>
                </a:moveTo>
                <a:cubicBezTo>
                  <a:pt x="48" y="0"/>
                  <a:pt x="121" y="0"/>
                  <a:pt x="169" y="0"/>
                </a:cubicBezTo>
                <a:cubicBezTo>
                  <a:pt x="169" y="0"/>
                  <a:pt x="242" y="0"/>
                  <a:pt x="242" y="0"/>
                </a:cubicBezTo>
                <a:cubicBezTo>
                  <a:pt x="242" y="0"/>
                  <a:pt x="291" y="0"/>
                  <a:pt x="291" y="0"/>
                </a:cubicBezTo>
                <a:cubicBezTo>
                  <a:pt x="291" y="0"/>
                  <a:pt x="339" y="0"/>
                  <a:pt x="339" y="0"/>
                </a:cubicBezTo>
                <a:lnTo>
                  <a:pt x="363" y="0"/>
                </a:lnTo>
                <a:cubicBezTo>
                  <a:pt x="363" y="0"/>
                  <a:pt x="388" y="0"/>
                  <a:pt x="388" y="0"/>
                </a:cubicBezTo>
                <a:cubicBezTo>
                  <a:pt x="436" y="0"/>
                  <a:pt x="485" y="0"/>
                  <a:pt x="436" y="0"/>
                </a:cubicBezTo>
              </a:path>
            </a:pathLst>
          </a:custGeom>
          <a:noFill/>
          <a:ln w="19080">
            <a:solidFill>
              <a:srgbClr val="14151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>
            <a:off x="1684080" y="623088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141515"/>
                </a:solidFill>
                <a:latin typeface="Arial"/>
              </a:rPr>
              <a:t>2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>
            <a:off x="1874880" y="5618160"/>
            <a:ext cx="131760" cy="360"/>
          </a:xfrm>
          <a:custGeom>
            <a:avLst/>
            <a:gdLst/>
            <a:ahLst/>
            <a:rect l="l" t="t" r="r" b="b"/>
            <a:pathLst>
              <a:path w="485" h="0">
                <a:moveTo>
                  <a:pt x="0" y="0"/>
                </a:moveTo>
                <a:cubicBezTo>
                  <a:pt x="48" y="0"/>
                  <a:pt x="121" y="0"/>
                  <a:pt x="169" y="0"/>
                </a:cubicBezTo>
                <a:cubicBezTo>
                  <a:pt x="169" y="0"/>
                  <a:pt x="242" y="0"/>
                  <a:pt x="242" y="0"/>
                </a:cubicBezTo>
                <a:cubicBezTo>
                  <a:pt x="242" y="0"/>
                  <a:pt x="291" y="0"/>
                  <a:pt x="291" y="0"/>
                </a:cubicBezTo>
                <a:cubicBezTo>
                  <a:pt x="291" y="0"/>
                  <a:pt x="339" y="0"/>
                  <a:pt x="339" y="0"/>
                </a:cubicBezTo>
                <a:lnTo>
                  <a:pt x="363" y="0"/>
                </a:lnTo>
                <a:cubicBezTo>
                  <a:pt x="363" y="0"/>
                  <a:pt x="388" y="0"/>
                  <a:pt x="388" y="0"/>
                </a:cubicBezTo>
                <a:cubicBezTo>
                  <a:pt x="436" y="0"/>
                  <a:pt x="485" y="0"/>
                  <a:pt x="436" y="0"/>
                </a:cubicBezTo>
              </a:path>
            </a:pathLst>
          </a:custGeom>
          <a:noFill/>
          <a:ln w="19080">
            <a:solidFill>
              <a:srgbClr val="14151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1684080" y="554508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141515"/>
                </a:solidFill>
                <a:latin typeface="Arial"/>
              </a:rPr>
              <a:t>5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50" name="" descr=""/>
          <p:cNvPicPr/>
          <p:nvPr/>
        </p:nvPicPr>
        <p:blipFill>
          <a:blip r:embed="rId4"/>
          <a:srcRect l="0" t="0" r="1437" b="0"/>
          <a:stretch/>
        </p:blipFill>
        <p:spPr>
          <a:xfrm>
            <a:off x="2079720" y="6539040"/>
            <a:ext cx="2579760" cy="1569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51" name="" descr=""/>
          <p:cNvPicPr/>
          <p:nvPr/>
        </p:nvPicPr>
        <p:blipFill>
          <a:blip r:embed="rId5"/>
          <a:stretch/>
        </p:blipFill>
        <p:spPr>
          <a:xfrm>
            <a:off x="2079720" y="6805440"/>
            <a:ext cx="2579760" cy="198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152" name=""/>
          <p:cNvSpPr/>
          <p:nvPr/>
        </p:nvSpPr>
        <p:spPr>
          <a:xfrm>
            <a:off x="1874880" y="6667560"/>
            <a:ext cx="131760" cy="360"/>
          </a:xfrm>
          <a:custGeom>
            <a:avLst/>
            <a:gdLst/>
            <a:ahLst/>
            <a:rect l="l" t="t" r="r" b="b"/>
            <a:pathLst>
              <a:path w="485" h="0">
                <a:moveTo>
                  <a:pt x="0" y="0"/>
                </a:moveTo>
                <a:cubicBezTo>
                  <a:pt x="48" y="0"/>
                  <a:pt x="121" y="0"/>
                  <a:pt x="169" y="0"/>
                </a:cubicBezTo>
                <a:cubicBezTo>
                  <a:pt x="169" y="0"/>
                  <a:pt x="242" y="0"/>
                  <a:pt x="242" y="0"/>
                </a:cubicBezTo>
                <a:cubicBezTo>
                  <a:pt x="242" y="0"/>
                  <a:pt x="291" y="0"/>
                  <a:pt x="291" y="0"/>
                </a:cubicBezTo>
                <a:cubicBezTo>
                  <a:pt x="291" y="0"/>
                  <a:pt x="339" y="0"/>
                  <a:pt x="339" y="0"/>
                </a:cubicBezTo>
                <a:lnTo>
                  <a:pt x="363" y="0"/>
                </a:lnTo>
                <a:cubicBezTo>
                  <a:pt x="363" y="0"/>
                  <a:pt x="388" y="0"/>
                  <a:pt x="388" y="0"/>
                </a:cubicBezTo>
                <a:cubicBezTo>
                  <a:pt x="436" y="0"/>
                  <a:pt x="485" y="0"/>
                  <a:pt x="436" y="0"/>
                </a:cubicBezTo>
              </a:path>
            </a:pathLst>
          </a:custGeom>
          <a:noFill/>
          <a:ln w="19080">
            <a:solidFill>
              <a:srgbClr val="14151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>
            <a:off x="1684080" y="659592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141515"/>
                </a:solidFill>
                <a:latin typeface="Arial"/>
              </a:rPr>
              <a:t>2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>
            <a:off x="1874880" y="6934320"/>
            <a:ext cx="131760" cy="360"/>
          </a:xfrm>
          <a:custGeom>
            <a:avLst/>
            <a:gdLst/>
            <a:ahLst/>
            <a:rect l="l" t="t" r="r" b="b"/>
            <a:pathLst>
              <a:path w="485" h="0">
                <a:moveTo>
                  <a:pt x="0" y="0"/>
                </a:moveTo>
                <a:cubicBezTo>
                  <a:pt x="48" y="0"/>
                  <a:pt x="121" y="0"/>
                  <a:pt x="169" y="0"/>
                </a:cubicBezTo>
                <a:cubicBezTo>
                  <a:pt x="169" y="0"/>
                  <a:pt x="242" y="0"/>
                  <a:pt x="242" y="0"/>
                </a:cubicBezTo>
                <a:cubicBezTo>
                  <a:pt x="242" y="0"/>
                  <a:pt x="291" y="0"/>
                  <a:pt x="291" y="0"/>
                </a:cubicBezTo>
                <a:cubicBezTo>
                  <a:pt x="291" y="0"/>
                  <a:pt x="339" y="0"/>
                  <a:pt x="339" y="0"/>
                </a:cubicBezTo>
                <a:lnTo>
                  <a:pt x="363" y="0"/>
                </a:lnTo>
                <a:cubicBezTo>
                  <a:pt x="363" y="0"/>
                  <a:pt x="388" y="0"/>
                  <a:pt x="388" y="0"/>
                </a:cubicBezTo>
                <a:cubicBezTo>
                  <a:pt x="436" y="0"/>
                  <a:pt x="485" y="0"/>
                  <a:pt x="436" y="0"/>
                </a:cubicBezTo>
              </a:path>
            </a:pathLst>
          </a:custGeom>
          <a:noFill/>
          <a:ln w="19080">
            <a:solidFill>
              <a:srgbClr val="14151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1684080" y="686268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141515"/>
                </a:solidFill>
                <a:latin typeface="Arial"/>
              </a:rPr>
              <a:t>4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>
            <a:off x="4711680" y="5978520"/>
            <a:ext cx="131760" cy="360"/>
          </a:xfrm>
          <a:custGeom>
            <a:avLst/>
            <a:gdLst/>
            <a:ahLst/>
            <a:rect l="l" t="t" r="r" b="b"/>
            <a:pathLst>
              <a:path w="485" h="0">
                <a:moveTo>
                  <a:pt x="0" y="0"/>
                </a:moveTo>
                <a:cubicBezTo>
                  <a:pt x="48" y="0"/>
                  <a:pt x="121" y="0"/>
                  <a:pt x="169" y="0"/>
                </a:cubicBezTo>
                <a:cubicBezTo>
                  <a:pt x="169" y="0"/>
                  <a:pt x="242" y="0"/>
                  <a:pt x="242" y="0"/>
                </a:cubicBezTo>
                <a:cubicBezTo>
                  <a:pt x="242" y="0"/>
                  <a:pt x="291" y="0"/>
                  <a:pt x="291" y="0"/>
                </a:cubicBezTo>
                <a:cubicBezTo>
                  <a:pt x="291" y="0"/>
                  <a:pt x="339" y="0"/>
                  <a:pt x="339" y="0"/>
                </a:cubicBezTo>
                <a:lnTo>
                  <a:pt x="363" y="0"/>
                </a:lnTo>
                <a:cubicBezTo>
                  <a:pt x="363" y="0"/>
                  <a:pt x="388" y="0"/>
                  <a:pt x="388" y="0"/>
                </a:cubicBezTo>
                <a:cubicBezTo>
                  <a:pt x="436" y="0"/>
                  <a:pt x="485" y="0"/>
                  <a:pt x="436" y="0"/>
                </a:cubicBezTo>
              </a:path>
            </a:pathLst>
          </a:custGeom>
          <a:noFill/>
          <a:ln w="19080">
            <a:solidFill>
              <a:srgbClr val="14151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>
            <a:off x="4711680" y="6326280"/>
            <a:ext cx="131760" cy="360"/>
          </a:xfrm>
          <a:custGeom>
            <a:avLst/>
            <a:gdLst/>
            <a:ahLst/>
            <a:rect l="l" t="t" r="r" b="b"/>
            <a:pathLst>
              <a:path w="485" h="0">
                <a:moveTo>
                  <a:pt x="0" y="0"/>
                </a:moveTo>
                <a:cubicBezTo>
                  <a:pt x="48" y="0"/>
                  <a:pt x="121" y="0"/>
                  <a:pt x="169" y="0"/>
                </a:cubicBezTo>
                <a:cubicBezTo>
                  <a:pt x="169" y="0"/>
                  <a:pt x="242" y="0"/>
                  <a:pt x="242" y="0"/>
                </a:cubicBezTo>
                <a:cubicBezTo>
                  <a:pt x="242" y="0"/>
                  <a:pt x="291" y="0"/>
                  <a:pt x="291" y="0"/>
                </a:cubicBezTo>
                <a:cubicBezTo>
                  <a:pt x="291" y="0"/>
                  <a:pt x="339" y="0"/>
                  <a:pt x="339" y="0"/>
                </a:cubicBezTo>
                <a:lnTo>
                  <a:pt x="363" y="0"/>
                </a:lnTo>
                <a:cubicBezTo>
                  <a:pt x="363" y="0"/>
                  <a:pt x="388" y="0"/>
                  <a:pt x="388" y="0"/>
                </a:cubicBezTo>
                <a:cubicBezTo>
                  <a:pt x="436" y="0"/>
                  <a:pt x="485" y="0"/>
                  <a:pt x="436" y="0"/>
                </a:cubicBezTo>
              </a:path>
            </a:pathLst>
          </a:custGeom>
          <a:noFill/>
          <a:ln w="19080">
            <a:solidFill>
              <a:srgbClr val="14151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>
            <a:off x="4711680" y="5646600"/>
            <a:ext cx="131760" cy="360"/>
          </a:xfrm>
          <a:custGeom>
            <a:avLst/>
            <a:gdLst/>
            <a:ahLst/>
            <a:rect l="l" t="t" r="r" b="b"/>
            <a:pathLst>
              <a:path w="485" h="0">
                <a:moveTo>
                  <a:pt x="0" y="0"/>
                </a:moveTo>
                <a:cubicBezTo>
                  <a:pt x="48" y="0"/>
                  <a:pt x="121" y="0"/>
                  <a:pt x="169" y="0"/>
                </a:cubicBezTo>
                <a:cubicBezTo>
                  <a:pt x="169" y="0"/>
                  <a:pt x="242" y="0"/>
                  <a:pt x="242" y="0"/>
                </a:cubicBezTo>
                <a:cubicBezTo>
                  <a:pt x="242" y="0"/>
                  <a:pt x="291" y="0"/>
                  <a:pt x="291" y="0"/>
                </a:cubicBezTo>
                <a:cubicBezTo>
                  <a:pt x="291" y="0"/>
                  <a:pt x="339" y="0"/>
                  <a:pt x="339" y="0"/>
                </a:cubicBezTo>
                <a:lnTo>
                  <a:pt x="363" y="0"/>
                </a:lnTo>
                <a:cubicBezTo>
                  <a:pt x="363" y="0"/>
                  <a:pt x="388" y="0"/>
                  <a:pt x="388" y="0"/>
                </a:cubicBezTo>
                <a:cubicBezTo>
                  <a:pt x="436" y="0"/>
                  <a:pt x="485" y="0"/>
                  <a:pt x="436" y="0"/>
                </a:cubicBezTo>
              </a:path>
            </a:pathLst>
          </a:custGeom>
          <a:noFill/>
          <a:ln w="19080">
            <a:solidFill>
              <a:srgbClr val="14151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>
            <a:off x="4711680" y="6635880"/>
            <a:ext cx="131760" cy="360"/>
          </a:xfrm>
          <a:custGeom>
            <a:avLst/>
            <a:gdLst/>
            <a:ahLst/>
            <a:rect l="l" t="t" r="r" b="b"/>
            <a:pathLst>
              <a:path w="485" h="0">
                <a:moveTo>
                  <a:pt x="0" y="0"/>
                </a:moveTo>
                <a:cubicBezTo>
                  <a:pt x="48" y="0"/>
                  <a:pt x="121" y="0"/>
                  <a:pt x="169" y="0"/>
                </a:cubicBezTo>
                <a:cubicBezTo>
                  <a:pt x="169" y="0"/>
                  <a:pt x="242" y="0"/>
                  <a:pt x="242" y="0"/>
                </a:cubicBezTo>
                <a:cubicBezTo>
                  <a:pt x="242" y="0"/>
                  <a:pt x="291" y="0"/>
                  <a:pt x="291" y="0"/>
                </a:cubicBezTo>
                <a:cubicBezTo>
                  <a:pt x="291" y="0"/>
                  <a:pt x="339" y="0"/>
                  <a:pt x="339" y="0"/>
                </a:cubicBezTo>
                <a:lnTo>
                  <a:pt x="363" y="0"/>
                </a:lnTo>
                <a:cubicBezTo>
                  <a:pt x="363" y="0"/>
                  <a:pt x="388" y="0"/>
                  <a:pt x="388" y="0"/>
                </a:cubicBezTo>
                <a:cubicBezTo>
                  <a:pt x="436" y="0"/>
                  <a:pt x="485" y="0"/>
                  <a:pt x="436" y="0"/>
                </a:cubicBezTo>
              </a:path>
            </a:pathLst>
          </a:custGeom>
          <a:noFill/>
          <a:ln w="19080">
            <a:solidFill>
              <a:srgbClr val="14151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4711680" y="6905520"/>
            <a:ext cx="131760" cy="360"/>
          </a:xfrm>
          <a:custGeom>
            <a:avLst/>
            <a:gdLst/>
            <a:ahLst/>
            <a:rect l="l" t="t" r="r" b="b"/>
            <a:pathLst>
              <a:path w="485" h="0">
                <a:moveTo>
                  <a:pt x="0" y="0"/>
                </a:moveTo>
                <a:cubicBezTo>
                  <a:pt x="48" y="0"/>
                  <a:pt x="121" y="0"/>
                  <a:pt x="169" y="0"/>
                </a:cubicBezTo>
                <a:cubicBezTo>
                  <a:pt x="169" y="0"/>
                  <a:pt x="242" y="0"/>
                  <a:pt x="242" y="0"/>
                </a:cubicBezTo>
                <a:cubicBezTo>
                  <a:pt x="242" y="0"/>
                  <a:pt x="291" y="0"/>
                  <a:pt x="291" y="0"/>
                </a:cubicBezTo>
                <a:cubicBezTo>
                  <a:pt x="291" y="0"/>
                  <a:pt x="339" y="0"/>
                  <a:pt x="339" y="0"/>
                </a:cubicBezTo>
                <a:lnTo>
                  <a:pt x="363" y="0"/>
                </a:lnTo>
                <a:cubicBezTo>
                  <a:pt x="363" y="0"/>
                  <a:pt x="388" y="0"/>
                  <a:pt x="388" y="0"/>
                </a:cubicBezTo>
                <a:cubicBezTo>
                  <a:pt x="436" y="0"/>
                  <a:pt x="485" y="0"/>
                  <a:pt x="436" y="0"/>
                </a:cubicBezTo>
              </a:path>
            </a:pathLst>
          </a:custGeom>
          <a:noFill/>
          <a:ln w="19080">
            <a:solidFill>
              <a:srgbClr val="14151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>
            <a:off x="1679400" y="5264280"/>
            <a:ext cx="162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141515"/>
                </a:solidFill>
                <a:latin typeface="Arial"/>
              </a:rPr>
              <a:t>k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>
            <a:off x="2324160" y="4938840"/>
            <a:ext cx="834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wild typ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>
            <a:off x="3672360" y="4938840"/>
            <a:ext cx="694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de-DE" sz="1200" spc="-1" strike="noStrike">
                <a:solidFill>
                  <a:srgbClr val="000000"/>
                </a:solidFill>
                <a:latin typeface="Arial"/>
              </a:rPr>
              <a:t>Atp7b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</a:rPr>
              <a:t>-/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>
            <a:off x="2089080" y="526428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>
            <a:off x="2384280" y="526428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Arial"/>
              </a:rPr>
              <a:t>1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>
            <a:off x="2697120" y="526428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Arial"/>
              </a:rPr>
              <a:t>1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>
            <a:off x="3019320" y="526428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Arial"/>
              </a:rPr>
              <a:t>2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>
            <a:off x="3344760" y="526428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Arial"/>
              </a:rPr>
              <a:t>1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>
            <a:off x="3657600" y="526428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Arial"/>
              </a:rPr>
              <a:t>1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>
            <a:off x="3975120" y="526428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Arial"/>
              </a:rPr>
              <a:t>2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>
            <a:off x="4294080" y="526428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Arial"/>
              </a:rPr>
              <a:t>2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"/>
          <p:cNvSpPr/>
          <p:nvPr/>
        </p:nvSpPr>
        <p:spPr>
          <a:xfrm>
            <a:off x="4792320" y="5292720"/>
            <a:ext cx="797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141515"/>
                </a:solidFill>
                <a:latin typeface="Arial"/>
              </a:rPr>
              <a:t>age (months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2-18T15:38:14Z</dcterms:created>
  <dc:creator>user</dc:creator>
  <dc:description/>
  <dc:language>en-US</dc:language>
  <cp:lastModifiedBy>Ralf</cp:lastModifiedBy>
  <dcterms:modified xsi:type="dcterms:W3CDTF">2014-06-27T16:33:58Z</dcterms:modified>
  <cp:revision>11</cp:revision>
  <dc:subject/>
  <dc:title>Folie 1</dc:title>
</cp:coreProperties>
</file>